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408738" cy="82296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egna, Will (NIH/NCI) [E]" initials="PW([" lastIdx="1" clrIdx="0">
    <p:extLst>
      <p:ext uri="{19B8F6BF-5375-455C-9EA6-DF929625EA0E}">
        <p15:presenceInfo xmlns:p15="http://schemas.microsoft.com/office/powerpoint/2012/main" userId="S::pegnagj@nih.gov::db4a9cff-b0db-4e42-a5ed-a3cab3a6edd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700"/>
    <a:srgbClr val="3257FF"/>
    <a:srgbClr val="8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21" autoAdjust="0"/>
    <p:restoredTop sz="90955" autoAdjust="0"/>
  </p:normalViewPr>
  <p:slideViewPr>
    <p:cSldViewPr snapToGrid="0">
      <p:cViewPr varScale="1">
        <p:scale>
          <a:sx n="103" d="100"/>
          <a:sy n="103" d="100"/>
        </p:scale>
        <p:origin x="3024" y="1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15" d="100"/>
          <a:sy n="115" d="100"/>
        </p:scale>
        <p:origin x="840" y="20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8D4CF6-0977-BE4F-A739-430C1AB9B6E6}" type="datetimeFigureOut">
              <a:rPr lang="en-US" smtClean="0"/>
              <a:t>7/1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4413" y="1162050"/>
            <a:ext cx="24415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72783A-89BE-3349-9491-6532E4BCD8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615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656" y="1346836"/>
            <a:ext cx="5447427" cy="2865120"/>
          </a:xfrm>
        </p:spPr>
        <p:txBody>
          <a:bodyPr anchor="b"/>
          <a:lstStyle>
            <a:lvl1pPr algn="ctr">
              <a:defRPr sz="4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1092" y="4322446"/>
            <a:ext cx="4806554" cy="1986914"/>
          </a:xfrm>
        </p:spPr>
        <p:txBody>
          <a:bodyPr/>
          <a:lstStyle>
            <a:lvl1pPr marL="0" indent="0" algn="ctr">
              <a:buNone/>
              <a:defRPr sz="1682"/>
            </a:lvl1pPr>
            <a:lvl2pPr marL="320451" indent="0" algn="ctr">
              <a:buNone/>
              <a:defRPr sz="1402"/>
            </a:lvl2pPr>
            <a:lvl3pPr marL="640903" indent="0" algn="ctr">
              <a:buNone/>
              <a:defRPr sz="1262"/>
            </a:lvl3pPr>
            <a:lvl4pPr marL="961354" indent="0" algn="ctr">
              <a:buNone/>
              <a:defRPr sz="1121"/>
            </a:lvl4pPr>
            <a:lvl5pPr marL="1281806" indent="0" algn="ctr">
              <a:buNone/>
              <a:defRPr sz="1121"/>
            </a:lvl5pPr>
            <a:lvl6pPr marL="1602257" indent="0" algn="ctr">
              <a:buNone/>
              <a:defRPr sz="1121"/>
            </a:lvl6pPr>
            <a:lvl7pPr marL="1922709" indent="0" algn="ctr">
              <a:buNone/>
              <a:defRPr sz="1121"/>
            </a:lvl7pPr>
            <a:lvl8pPr marL="2243160" indent="0" algn="ctr">
              <a:buNone/>
              <a:defRPr sz="1121"/>
            </a:lvl8pPr>
            <a:lvl9pPr marL="2563612" indent="0" algn="ctr">
              <a:buNone/>
              <a:defRPr sz="112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932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741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6254" y="438150"/>
            <a:ext cx="1381884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601" y="438150"/>
            <a:ext cx="4065543" cy="697420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59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80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7263" y="2051688"/>
            <a:ext cx="5527537" cy="3423284"/>
          </a:xfrm>
        </p:spPr>
        <p:txBody>
          <a:bodyPr anchor="b"/>
          <a:lstStyle>
            <a:lvl1pPr>
              <a:defRPr sz="4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7263" y="5507358"/>
            <a:ext cx="5527537" cy="1800224"/>
          </a:xfrm>
        </p:spPr>
        <p:txBody>
          <a:bodyPr/>
          <a:lstStyle>
            <a:lvl1pPr marL="0" indent="0">
              <a:buNone/>
              <a:defRPr sz="1682">
                <a:solidFill>
                  <a:schemeClr val="tx1"/>
                </a:solidFill>
              </a:defRPr>
            </a:lvl1pPr>
            <a:lvl2pPr marL="320451" indent="0">
              <a:buNone/>
              <a:defRPr sz="1402">
                <a:solidFill>
                  <a:schemeClr val="tx1">
                    <a:tint val="75000"/>
                  </a:schemeClr>
                </a:solidFill>
              </a:defRPr>
            </a:lvl2pPr>
            <a:lvl3pPr marL="640903" indent="0">
              <a:buNone/>
              <a:defRPr sz="1262">
                <a:solidFill>
                  <a:schemeClr val="tx1">
                    <a:tint val="75000"/>
                  </a:schemeClr>
                </a:solidFill>
              </a:defRPr>
            </a:lvl3pPr>
            <a:lvl4pPr marL="961354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4pPr>
            <a:lvl5pPr marL="1281806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5pPr>
            <a:lvl6pPr marL="1602257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6pPr>
            <a:lvl7pPr marL="1922709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7pPr>
            <a:lvl8pPr marL="2243160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8pPr>
            <a:lvl9pPr marL="2563612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114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601" y="2190750"/>
            <a:ext cx="2723714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4423" y="2190750"/>
            <a:ext cx="2723714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941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438152"/>
            <a:ext cx="5527537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436" y="2017396"/>
            <a:ext cx="2711196" cy="988694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436" y="3006090"/>
            <a:ext cx="2711196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4424" y="2017396"/>
            <a:ext cx="2724548" cy="988694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4424" y="3006090"/>
            <a:ext cx="2724548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970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186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469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48640"/>
            <a:ext cx="2066985" cy="1920240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4548" y="1184912"/>
            <a:ext cx="3244424" cy="5848350"/>
          </a:xfrm>
        </p:spPr>
        <p:txBody>
          <a:bodyPr/>
          <a:lstStyle>
            <a:lvl1pPr>
              <a:defRPr sz="2243"/>
            </a:lvl1pPr>
            <a:lvl2pPr>
              <a:defRPr sz="1963"/>
            </a:lvl2pPr>
            <a:lvl3pPr>
              <a:defRPr sz="1682"/>
            </a:lvl3pPr>
            <a:lvl4pPr>
              <a:defRPr sz="1402"/>
            </a:lvl4pPr>
            <a:lvl5pPr>
              <a:defRPr sz="1402"/>
            </a:lvl5pPr>
            <a:lvl6pPr>
              <a:defRPr sz="1402"/>
            </a:lvl6pPr>
            <a:lvl7pPr>
              <a:defRPr sz="1402"/>
            </a:lvl7pPr>
            <a:lvl8pPr>
              <a:defRPr sz="1402"/>
            </a:lvl8pPr>
            <a:lvl9pPr>
              <a:defRPr sz="1402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468880"/>
            <a:ext cx="2066985" cy="4573906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602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48640"/>
            <a:ext cx="2066985" cy="1920240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4548" y="1184912"/>
            <a:ext cx="3244424" cy="5848350"/>
          </a:xfrm>
        </p:spPr>
        <p:txBody>
          <a:bodyPr anchor="t"/>
          <a:lstStyle>
            <a:lvl1pPr marL="0" indent="0">
              <a:buNone/>
              <a:defRPr sz="2243"/>
            </a:lvl1pPr>
            <a:lvl2pPr marL="320451" indent="0">
              <a:buNone/>
              <a:defRPr sz="1963"/>
            </a:lvl2pPr>
            <a:lvl3pPr marL="640903" indent="0">
              <a:buNone/>
              <a:defRPr sz="1682"/>
            </a:lvl3pPr>
            <a:lvl4pPr marL="961354" indent="0">
              <a:buNone/>
              <a:defRPr sz="1402"/>
            </a:lvl4pPr>
            <a:lvl5pPr marL="1281806" indent="0">
              <a:buNone/>
              <a:defRPr sz="1402"/>
            </a:lvl5pPr>
            <a:lvl6pPr marL="1602257" indent="0">
              <a:buNone/>
              <a:defRPr sz="1402"/>
            </a:lvl6pPr>
            <a:lvl7pPr marL="1922709" indent="0">
              <a:buNone/>
              <a:defRPr sz="1402"/>
            </a:lvl7pPr>
            <a:lvl8pPr marL="2243160" indent="0">
              <a:buNone/>
              <a:defRPr sz="1402"/>
            </a:lvl8pPr>
            <a:lvl9pPr marL="2563612" indent="0">
              <a:buNone/>
              <a:defRPr sz="140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468880"/>
            <a:ext cx="2066985" cy="4573906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380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601" y="438152"/>
            <a:ext cx="5527537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601" y="2190750"/>
            <a:ext cx="5527537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601" y="7627622"/>
            <a:ext cx="1441966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D87B62-44FB-4922-9900-6E44E035A1EB}" type="datetimeFigureOut">
              <a:rPr lang="en-US" smtClean="0"/>
              <a:t>7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2895" y="7627622"/>
            <a:ext cx="2162949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6171" y="7627622"/>
            <a:ext cx="1441966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726AA-C654-4B45-B817-05C90D707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058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903" rtl="0" eaLnBrk="1" latinLnBrk="0" hangingPunct="1">
        <a:lnSpc>
          <a:spcPct val="90000"/>
        </a:lnSpc>
        <a:spcBef>
          <a:spcPct val="0"/>
        </a:spcBef>
        <a:buNone/>
        <a:defRPr sz="3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226" indent="-160226" algn="l" defTabSz="640903" rtl="0" eaLnBrk="1" latinLnBrk="0" hangingPunct="1">
        <a:lnSpc>
          <a:spcPct val="90000"/>
        </a:lnSpc>
        <a:spcBef>
          <a:spcPts val="701"/>
        </a:spcBef>
        <a:buFont typeface="Arial" panose="020B0604020202020204" pitchFamily="34" charset="0"/>
        <a:buChar char="•"/>
        <a:defRPr sz="1963" kern="1200">
          <a:solidFill>
            <a:schemeClr val="tx1"/>
          </a:solidFill>
          <a:latin typeface="+mn-lt"/>
          <a:ea typeface="+mn-ea"/>
          <a:cs typeface="+mn-cs"/>
        </a:defRPr>
      </a:lvl1pPr>
      <a:lvl2pPr marL="480677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2" kern="1200">
          <a:solidFill>
            <a:schemeClr val="tx1"/>
          </a:solidFill>
          <a:latin typeface="+mn-lt"/>
          <a:ea typeface="+mn-ea"/>
          <a:cs typeface="+mn-cs"/>
        </a:defRPr>
      </a:lvl2pPr>
      <a:lvl3pPr marL="801129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2" kern="1200">
          <a:solidFill>
            <a:schemeClr val="tx1"/>
          </a:solidFill>
          <a:latin typeface="+mn-lt"/>
          <a:ea typeface="+mn-ea"/>
          <a:cs typeface="+mn-cs"/>
        </a:defRPr>
      </a:lvl3pPr>
      <a:lvl4pPr marL="1121580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442032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762483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2082935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403386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723838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1pPr>
      <a:lvl2pPr marL="320451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2pPr>
      <a:lvl3pPr marL="640903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3pPr>
      <a:lvl4pPr marL="961354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281806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602257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1922709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24316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563612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3FA6F05-FB19-9B49-8ECD-723CDC0953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6020394"/>
              </p:ext>
            </p:extLst>
          </p:nvPr>
        </p:nvGraphicFramePr>
        <p:xfrm>
          <a:off x="441324" y="841831"/>
          <a:ext cx="5526091" cy="5151211"/>
        </p:xfrm>
        <a:graphic>
          <a:graphicData uri="http://schemas.openxmlformats.org/drawingml/2006/table">
            <a:tbl>
              <a:tblPr/>
              <a:tblGrid>
                <a:gridCol w="71397">
                  <a:extLst>
                    <a:ext uri="{9D8B030D-6E8A-4147-A177-3AD203B41FA5}">
                      <a16:colId xmlns:a16="http://schemas.microsoft.com/office/drawing/2014/main" val="158956714"/>
                    </a:ext>
                  </a:extLst>
                </a:gridCol>
                <a:gridCol w="147553">
                  <a:extLst>
                    <a:ext uri="{9D8B030D-6E8A-4147-A177-3AD203B41FA5}">
                      <a16:colId xmlns:a16="http://schemas.microsoft.com/office/drawing/2014/main" val="46415915"/>
                    </a:ext>
                  </a:extLst>
                </a:gridCol>
                <a:gridCol w="728244">
                  <a:extLst>
                    <a:ext uri="{9D8B030D-6E8A-4147-A177-3AD203B41FA5}">
                      <a16:colId xmlns:a16="http://schemas.microsoft.com/office/drawing/2014/main" val="890389303"/>
                    </a:ext>
                  </a:extLst>
                </a:gridCol>
                <a:gridCol w="414100">
                  <a:extLst>
                    <a:ext uri="{9D8B030D-6E8A-4147-A177-3AD203B41FA5}">
                      <a16:colId xmlns:a16="http://schemas.microsoft.com/office/drawing/2014/main" val="2227146325"/>
                    </a:ext>
                  </a:extLst>
                </a:gridCol>
                <a:gridCol w="204670">
                  <a:extLst>
                    <a:ext uri="{9D8B030D-6E8A-4147-A177-3AD203B41FA5}">
                      <a16:colId xmlns:a16="http://schemas.microsoft.com/office/drawing/2014/main" val="3959497983"/>
                    </a:ext>
                  </a:extLst>
                </a:gridCol>
                <a:gridCol w="342703">
                  <a:extLst>
                    <a:ext uri="{9D8B030D-6E8A-4147-A177-3AD203B41FA5}">
                      <a16:colId xmlns:a16="http://schemas.microsoft.com/office/drawing/2014/main" val="1968168977"/>
                    </a:ext>
                  </a:extLst>
                </a:gridCol>
                <a:gridCol w="366502">
                  <a:extLst>
                    <a:ext uri="{9D8B030D-6E8A-4147-A177-3AD203B41FA5}">
                      <a16:colId xmlns:a16="http://schemas.microsoft.com/office/drawing/2014/main" val="2021818063"/>
                    </a:ext>
                  </a:extLst>
                </a:gridCol>
                <a:gridCol w="434480">
                  <a:extLst>
                    <a:ext uri="{9D8B030D-6E8A-4147-A177-3AD203B41FA5}">
                      <a16:colId xmlns:a16="http://schemas.microsoft.com/office/drawing/2014/main" val="490582050"/>
                    </a:ext>
                  </a:extLst>
                </a:gridCol>
                <a:gridCol w="127173">
                  <a:extLst>
                    <a:ext uri="{9D8B030D-6E8A-4147-A177-3AD203B41FA5}">
                      <a16:colId xmlns:a16="http://schemas.microsoft.com/office/drawing/2014/main" val="2635874428"/>
                    </a:ext>
                  </a:extLst>
                </a:gridCol>
                <a:gridCol w="147553">
                  <a:extLst>
                    <a:ext uri="{9D8B030D-6E8A-4147-A177-3AD203B41FA5}">
                      <a16:colId xmlns:a16="http://schemas.microsoft.com/office/drawing/2014/main" val="698463216"/>
                    </a:ext>
                  </a:extLst>
                </a:gridCol>
                <a:gridCol w="728244">
                  <a:extLst>
                    <a:ext uri="{9D8B030D-6E8A-4147-A177-3AD203B41FA5}">
                      <a16:colId xmlns:a16="http://schemas.microsoft.com/office/drawing/2014/main" val="76931720"/>
                    </a:ext>
                  </a:extLst>
                </a:gridCol>
                <a:gridCol w="414100">
                  <a:extLst>
                    <a:ext uri="{9D8B030D-6E8A-4147-A177-3AD203B41FA5}">
                      <a16:colId xmlns:a16="http://schemas.microsoft.com/office/drawing/2014/main" val="2492883231"/>
                    </a:ext>
                  </a:extLst>
                </a:gridCol>
                <a:gridCol w="204670">
                  <a:extLst>
                    <a:ext uri="{9D8B030D-6E8A-4147-A177-3AD203B41FA5}">
                      <a16:colId xmlns:a16="http://schemas.microsoft.com/office/drawing/2014/main" val="546177272"/>
                    </a:ext>
                  </a:extLst>
                </a:gridCol>
                <a:gridCol w="342703">
                  <a:extLst>
                    <a:ext uri="{9D8B030D-6E8A-4147-A177-3AD203B41FA5}">
                      <a16:colId xmlns:a16="http://schemas.microsoft.com/office/drawing/2014/main" val="2520661719"/>
                    </a:ext>
                  </a:extLst>
                </a:gridCol>
                <a:gridCol w="366502">
                  <a:extLst>
                    <a:ext uri="{9D8B030D-6E8A-4147-A177-3AD203B41FA5}">
                      <a16:colId xmlns:a16="http://schemas.microsoft.com/office/drawing/2014/main" val="3887447337"/>
                    </a:ext>
                  </a:extLst>
                </a:gridCol>
                <a:gridCol w="414100">
                  <a:extLst>
                    <a:ext uri="{9D8B030D-6E8A-4147-A177-3AD203B41FA5}">
                      <a16:colId xmlns:a16="http://schemas.microsoft.com/office/drawing/2014/main" val="1106689730"/>
                    </a:ext>
                  </a:extLst>
                </a:gridCol>
                <a:gridCol w="71397">
                  <a:extLst>
                    <a:ext uri="{9D8B030D-6E8A-4147-A177-3AD203B41FA5}">
                      <a16:colId xmlns:a16="http://schemas.microsoft.com/office/drawing/2014/main" val="2156748232"/>
                    </a:ext>
                  </a:extLst>
                </a:gridCol>
              </a:tblGrid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15"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 CRP and Cytokine: Data Evaluability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1733398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aluable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: Sepsi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: Missing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aluable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: Sepsi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: Missing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8001770"/>
                  </a:ext>
                </a:extLst>
              </a:tr>
              <a:tr h="9634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6862901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 CRP (Day 3)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2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5047686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211029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7549007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765034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85446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5450558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8366504"/>
                  </a:ext>
                </a:extLst>
              </a:tr>
              <a:tr h="9634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756035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N-</a:t>
                      </a:r>
                      <a:r>
                        <a:rPr lang="el-G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4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731608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617035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7237659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0935191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2373578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233606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5840186"/>
                  </a:ext>
                </a:extLst>
              </a:tr>
              <a:tr h="9634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138088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0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6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026725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4422863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6001747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1311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8111279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7851556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205191"/>
                  </a:ext>
                </a:extLst>
              </a:tr>
              <a:tr h="9634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481354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2p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8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9199011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6842629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4336971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253675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2583756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6504277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2314700"/>
                  </a:ext>
                </a:extLst>
              </a:tr>
              <a:tr h="9634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799337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3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-</a:t>
                      </a:r>
                      <a:r>
                        <a:rPr lang="el-G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069224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8943987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5149883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5595106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5237445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7322254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7385798"/>
                  </a:ext>
                </a:extLst>
              </a:tr>
              <a:tr h="9634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162195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B</a:t>
                      </a:r>
                    </a:p>
                  </a:txBody>
                  <a:tcPr marL="4769" marR="4769" marT="4769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A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5002937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401553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789857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 Level 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4725229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4211252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1 - Dosel Level 3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0225430"/>
                  </a:ext>
                </a:extLst>
              </a:tr>
              <a:tr h="10174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m B2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LS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3695216"/>
                  </a:ext>
                </a:extLst>
              </a:tr>
              <a:tr h="9634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769" marR="4769" marT="47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6575911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07A8B4C0-A758-2340-96BB-058DF18B1D77}"/>
              </a:ext>
            </a:extLst>
          </p:cNvPr>
          <p:cNvSpPr/>
          <p:nvPr/>
        </p:nvSpPr>
        <p:spPr>
          <a:xfrm>
            <a:off x="441324" y="517728"/>
            <a:ext cx="30283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b="1" dirty="0">
                <a:solidFill>
                  <a:srgbClr val="000000"/>
                </a:solidFill>
                <a:latin typeface="Calibri" panose="020F0502020204030204" pitchFamily="34" charset="0"/>
              </a:rPr>
              <a:t>Supplementary Table 2: Serum CRP and Cytokine Data Evaluability</a:t>
            </a:r>
          </a:p>
        </p:txBody>
      </p:sp>
    </p:spTree>
    <p:extLst>
      <p:ext uri="{BB962C8B-B14F-4D97-AF65-F5344CB8AC3E}">
        <p14:creationId xmlns:p14="http://schemas.microsoft.com/office/powerpoint/2010/main" val="3880978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66</TotalTime>
  <Words>850</Words>
  <Application>Microsoft Macintosh PowerPoint</Application>
  <PresentationFormat>Custom</PresentationFormat>
  <Paragraphs>57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wine, Christine (NIH/NCI) [E]</dc:creator>
  <cp:lastModifiedBy>Hurlbert, Cynthia (NIH/NCI) [C]</cp:lastModifiedBy>
  <cp:revision>193</cp:revision>
  <cp:lastPrinted>2021-08-25T14:46:29Z</cp:lastPrinted>
  <dcterms:created xsi:type="dcterms:W3CDTF">2018-08-14T17:36:13Z</dcterms:created>
  <dcterms:modified xsi:type="dcterms:W3CDTF">2022-07-15T19:47:13Z</dcterms:modified>
</cp:coreProperties>
</file>